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7" d="100"/>
          <a:sy n="57" d="100"/>
        </p:scale>
        <p:origin x="-1061" y="1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CD7643-741C-4776-851E-A67B32BEBAF6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F3D04-0D8F-4FF3-AE97-8BC3ED80A67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5645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4F3D04-0D8F-4FF3-AE97-8BC3ED80A672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-36512" y="2179880"/>
            <a:ext cx="2880320" cy="1968624"/>
            <a:chOff x="-36512" y="260648"/>
            <a:chExt cx="2880320" cy="1968624"/>
          </a:xfrm>
        </p:grpSpPr>
        <p:pic>
          <p:nvPicPr>
            <p:cNvPr id="2" name="图片 1" descr="hcs-1 178s-1.bmp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260648"/>
              <a:ext cx="2453648" cy="1968624"/>
            </a:xfrm>
            <a:prstGeom prst="rect">
              <a:avLst/>
            </a:prstGeom>
          </p:spPr>
        </p:pic>
        <p:sp>
          <p:nvSpPr>
            <p:cNvPr id="3" name="椭圆 2"/>
            <p:cNvSpPr/>
            <p:nvPr/>
          </p:nvSpPr>
          <p:spPr>
            <a:xfrm rot="3151294" flipV="1">
              <a:off x="814836" y="1416833"/>
              <a:ext cx="500283" cy="46994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TextBox 55"/>
            <p:cNvSpPr txBox="1"/>
            <p:nvPr/>
          </p:nvSpPr>
          <p:spPr>
            <a:xfrm>
              <a:off x="1311920" y="404664"/>
              <a:ext cx="15318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333</a:t>
              </a:r>
              <a:endParaRPr lang="zh-CN" altLang="en-US" sz="1200" b="1" i="1" baseline="30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-36512" y="404664"/>
              <a:ext cx="13244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-hel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318</a:t>
              </a:r>
              <a:endParaRPr lang="zh-CN" altLang="en-US" sz="1200" b="1" i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1" name="椭圆 10"/>
            <p:cNvSpPr/>
            <p:nvPr/>
          </p:nvSpPr>
          <p:spPr>
            <a:xfrm rot="18967073">
              <a:off x="1322431" y="1201808"/>
              <a:ext cx="564259" cy="55629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3090651" y="2179880"/>
            <a:ext cx="2921509" cy="1969200"/>
            <a:chOff x="2555776" y="260648"/>
            <a:chExt cx="2921509" cy="1969200"/>
          </a:xfrm>
        </p:grpSpPr>
        <p:pic>
          <p:nvPicPr>
            <p:cNvPr id="7" name="图片 6" descr="hcs-2 178s-2-2-8dj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627784" y="260648"/>
              <a:ext cx="2454365" cy="1969200"/>
            </a:xfrm>
            <a:prstGeom prst="rect">
              <a:avLst/>
            </a:prstGeom>
          </p:spPr>
        </p:pic>
        <p:sp>
          <p:nvSpPr>
            <p:cNvPr id="8" name="TextBox 73"/>
            <p:cNvSpPr txBox="1"/>
            <p:nvPr/>
          </p:nvSpPr>
          <p:spPr>
            <a:xfrm>
              <a:off x="3995936" y="404664"/>
              <a:ext cx="14813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445</a:t>
              </a:r>
              <a:endParaRPr lang="zh-CN" altLang="en-US" sz="1200" b="1" i="1" baseline="30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61"/>
            <p:cNvSpPr txBox="1"/>
            <p:nvPr/>
          </p:nvSpPr>
          <p:spPr>
            <a:xfrm>
              <a:off x="2555776" y="405429"/>
              <a:ext cx="1512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hel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430</a:t>
              </a:r>
              <a:endParaRPr lang="zh-CN" altLang="en-US" sz="1200" b="1" i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" name="椭圆 9"/>
            <p:cNvSpPr/>
            <p:nvPr/>
          </p:nvSpPr>
          <p:spPr>
            <a:xfrm rot="3151294" flipV="1">
              <a:off x="3335116" y="1097628"/>
              <a:ext cx="500283" cy="46994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椭圆 11"/>
            <p:cNvSpPr/>
            <p:nvPr/>
          </p:nvSpPr>
          <p:spPr>
            <a:xfrm rot="18967073">
              <a:off x="3893937" y="954611"/>
              <a:ext cx="564259" cy="55629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6209004" y="2148707"/>
            <a:ext cx="2971508" cy="2000373"/>
            <a:chOff x="5220072" y="229475"/>
            <a:chExt cx="2971508" cy="2000373"/>
          </a:xfrm>
        </p:grpSpPr>
        <p:pic>
          <p:nvPicPr>
            <p:cNvPr id="15" name="图片 14" descr="hcs-3 178s-3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292080" y="260648"/>
              <a:ext cx="2454365" cy="1969200"/>
            </a:xfrm>
            <a:prstGeom prst="rect">
              <a:avLst/>
            </a:prstGeom>
          </p:spPr>
        </p:pic>
        <p:sp>
          <p:nvSpPr>
            <p:cNvPr id="16" name="椭圆 15"/>
            <p:cNvSpPr/>
            <p:nvPr/>
          </p:nvSpPr>
          <p:spPr>
            <a:xfrm rot="3151294" flipV="1">
              <a:off x="5956673" y="1087237"/>
              <a:ext cx="500283" cy="46994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椭圆 16"/>
            <p:cNvSpPr/>
            <p:nvPr/>
          </p:nvSpPr>
          <p:spPr>
            <a:xfrm rot="18967073">
              <a:off x="6506817" y="1043547"/>
              <a:ext cx="836233" cy="594442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TextBox 83"/>
            <p:cNvSpPr txBox="1"/>
            <p:nvPr/>
          </p:nvSpPr>
          <p:spPr>
            <a:xfrm>
              <a:off x="6670623" y="229475"/>
              <a:ext cx="15209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333</a:t>
              </a:r>
              <a:endParaRPr lang="zh-CN" altLang="en-US" sz="1200" b="1" i="1" baseline="30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78"/>
            <p:cNvSpPr txBox="1"/>
            <p:nvPr/>
          </p:nvSpPr>
          <p:spPr>
            <a:xfrm>
              <a:off x="5220072" y="259919"/>
              <a:ext cx="1901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hel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318</a:t>
              </a:r>
              <a:endParaRPr lang="zh-CN" altLang="en-US" sz="1200" b="1" i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3059832" y="69269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 5a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and 5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594727" y="476672"/>
            <a:ext cx="2685657" cy="2066400"/>
            <a:chOff x="0" y="2492896"/>
            <a:chExt cx="2685657" cy="2066400"/>
          </a:xfrm>
        </p:grpSpPr>
        <p:pic>
          <p:nvPicPr>
            <p:cNvPr id="5" name="图片 4" descr="hcs178-q.bmp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2492896"/>
              <a:ext cx="2575513" cy="2066400"/>
            </a:xfrm>
            <a:prstGeom prst="rect">
              <a:avLst/>
            </a:prstGeom>
          </p:spPr>
        </p:pic>
        <p:sp>
          <p:nvSpPr>
            <p:cNvPr id="6" name="椭圆 5"/>
            <p:cNvSpPr/>
            <p:nvPr/>
          </p:nvSpPr>
          <p:spPr>
            <a:xfrm rot="18967073">
              <a:off x="1139866" y="3482815"/>
              <a:ext cx="710719" cy="51106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TextBox 77"/>
            <p:cNvSpPr txBox="1"/>
            <p:nvPr/>
          </p:nvSpPr>
          <p:spPr>
            <a:xfrm>
              <a:off x="1331640" y="2708920"/>
              <a:ext cx="13540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291</a:t>
              </a:r>
              <a:endParaRPr lang="zh-CN" altLang="en-US" sz="1200" b="1" i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483768" y="0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 5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259023" y="476672"/>
            <a:ext cx="2880320" cy="2066400"/>
            <a:chOff x="2699792" y="476672"/>
            <a:chExt cx="2880320" cy="2066400"/>
          </a:xfrm>
        </p:grpSpPr>
        <p:pic>
          <p:nvPicPr>
            <p:cNvPr id="9" name="图片 8" descr="hcs 334-445.bmp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699792" y="476672"/>
              <a:ext cx="2575513" cy="2066400"/>
            </a:xfrm>
            <a:prstGeom prst="rect">
              <a:avLst/>
            </a:prstGeom>
          </p:spPr>
        </p:pic>
        <p:sp>
          <p:nvSpPr>
            <p:cNvPr id="10" name="椭圆 9"/>
            <p:cNvSpPr/>
            <p:nvPr/>
          </p:nvSpPr>
          <p:spPr>
            <a:xfrm rot="18967073">
              <a:off x="3971385" y="1577360"/>
              <a:ext cx="710719" cy="51106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TextBox 94"/>
            <p:cNvSpPr txBox="1"/>
            <p:nvPr/>
          </p:nvSpPr>
          <p:spPr>
            <a:xfrm>
              <a:off x="4081555" y="682947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34-445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5995327" y="476672"/>
            <a:ext cx="2907544" cy="2066400"/>
            <a:chOff x="5436096" y="476672"/>
            <a:chExt cx="2907544" cy="2066400"/>
          </a:xfrm>
        </p:grpSpPr>
        <p:pic>
          <p:nvPicPr>
            <p:cNvPr id="13" name="图片 12" descr="hcs-394-390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436096" y="476672"/>
              <a:ext cx="2575513" cy="2066400"/>
            </a:xfrm>
            <a:prstGeom prst="rect">
              <a:avLst/>
            </a:prstGeom>
          </p:spPr>
        </p:pic>
        <p:sp>
          <p:nvSpPr>
            <p:cNvPr id="14" name="椭圆 13"/>
            <p:cNvSpPr/>
            <p:nvPr/>
          </p:nvSpPr>
          <p:spPr>
            <a:xfrm rot="18967073">
              <a:off x="6447676" y="1189230"/>
              <a:ext cx="710719" cy="51106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TextBox 94"/>
            <p:cNvSpPr txBox="1"/>
            <p:nvPr/>
          </p:nvSpPr>
          <p:spPr>
            <a:xfrm>
              <a:off x="6845083" y="620688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34-390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611560" y="3018784"/>
            <a:ext cx="2972381" cy="2066400"/>
            <a:chOff x="611560" y="2708920"/>
            <a:chExt cx="2972381" cy="2066400"/>
          </a:xfrm>
        </p:grpSpPr>
        <p:pic>
          <p:nvPicPr>
            <p:cNvPr id="17" name="图片 16" descr="hcs-334-378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611560" y="2708920"/>
              <a:ext cx="2575513" cy="2066400"/>
            </a:xfrm>
            <a:prstGeom prst="rect">
              <a:avLst/>
            </a:prstGeom>
          </p:spPr>
        </p:pic>
        <p:sp>
          <p:nvSpPr>
            <p:cNvPr id="18" name="椭圆 17"/>
            <p:cNvSpPr/>
            <p:nvPr/>
          </p:nvSpPr>
          <p:spPr>
            <a:xfrm rot="18967073">
              <a:off x="1961669" y="3491132"/>
              <a:ext cx="710719" cy="51106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TextBox 94"/>
            <p:cNvSpPr txBox="1"/>
            <p:nvPr/>
          </p:nvSpPr>
          <p:spPr>
            <a:xfrm>
              <a:off x="2085384" y="2739364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34-378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3275856" y="3027396"/>
            <a:ext cx="2650685" cy="2066400"/>
            <a:chOff x="3275856" y="3027396"/>
            <a:chExt cx="2650685" cy="2066400"/>
          </a:xfrm>
        </p:grpSpPr>
        <p:pic>
          <p:nvPicPr>
            <p:cNvPr id="21" name="图片 20" descr="hcs 379-445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275856" y="3027396"/>
              <a:ext cx="2575513" cy="2066400"/>
            </a:xfrm>
            <a:prstGeom prst="rect">
              <a:avLst/>
            </a:prstGeom>
          </p:spPr>
        </p:pic>
        <p:sp>
          <p:nvSpPr>
            <p:cNvPr id="23" name="TextBox 94"/>
            <p:cNvSpPr txBox="1"/>
            <p:nvPr/>
          </p:nvSpPr>
          <p:spPr>
            <a:xfrm>
              <a:off x="4427984" y="3068960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9-445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4" name="椭圆 23"/>
            <p:cNvSpPr/>
            <p:nvPr/>
          </p:nvSpPr>
          <p:spPr>
            <a:xfrm rot="18967073">
              <a:off x="4561845" y="3988118"/>
              <a:ext cx="588089" cy="475646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6011431" y="3028125"/>
            <a:ext cx="2867438" cy="2066400"/>
            <a:chOff x="6011431" y="3028125"/>
            <a:chExt cx="2867438" cy="2066400"/>
          </a:xfrm>
        </p:grpSpPr>
        <p:pic>
          <p:nvPicPr>
            <p:cNvPr id="25" name="图片 24" descr="hcs-391-445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6011431" y="3028125"/>
              <a:ext cx="2575513" cy="2066400"/>
            </a:xfrm>
            <a:prstGeom prst="rect">
              <a:avLst/>
            </a:prstGeom>
          </p:spPr>
        </p:pic>
        <p:sp>
          <p:nvSpPr>
            <p:cNvPr id="26" name="椭圆 25"/>
            <p:cNvSpPr/>
            <p:nvPr/>
          </p:nvSpPr>
          <p:spPr>
            <a:xfrm rot="18967073">
              <a:off x="7296217" y="3784619"/>
              <a:ext cx="557074" cy="611777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7" name="TextBox 94"/>
            <p:cNvSpPr txBox="1"/>
            <p:nvPr/>
          </p:nvSpPr>
          <p:spPr>
            <a:xfrm>
              <a:off x="7380312" y="3068960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91-445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15816" y="0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 5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971600" y="1916832"/>
            <a:ext cx="2909002" cy="2066400"/>
            <a:chOff x="662057" y="836712"/>
            <a:chExt cx="2909002" cy="2066400"/>
          </a:xfrm>
        </p:grpSpPr>
        <p:pic>
          <p:nvPicPr>
            <p:cNvPr id="3" name="图片 2" descr="HCS-291-375-390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755576" y="836712"/>
              <a:ext cx="2575513" cy="2066400"/>
            </a:xfrm>
            <a:prstGeom prst="rect">
              <a:avLst/>
            </a:prstGeom>
          </p:spPr>
        </p:pic>
        <p:sp>
          <p:nvSpPr>
            <p:cNvPr id="4" name="椭圆 3"/>
            <p:cNvSpPr/>
            <p:nvPr/>
          </p:nvSpPr>
          <p:spPr>
            <a:xfrm rot="3151294" flipV="1">
              <a:off x="1318730" y="1670377"/>
              <a:ext cx="533112" cy="606479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椭圆 4"/>
            <p:cNvSpPr/>
            <p:nvPr/>
          </p:nvSpPr>
          <p:spPr>
            <a:xfrm rot="18967073">
              <a:off x="1800754" y="1722105"/>
              <a:ext cx="710719" cy="51106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TextBox 94"/>
            <p:cNvSpPr txBox="1"/>
            <p:nvPr/>
          </p:nvSpPr>
          <p:spPr>
            <a:xfrm>
              <a:off x="2072502" y="867156"/>
              <a:ext cx="14985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α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390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" name="TextBox 94"/>
            <p:cNvSpPr txBox="1"/>
            <p:nvPr/>
          </p:nvSpPr>
          <p:spPr>
            <a:xfrm>
              <a:off x="662057" y="867156"/>
              <a:ext cx="1892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-hel</a:t>
              </a:r>
              <a:r>
                <a:rPr lang="en-US" altLang="zh-CN" sz="12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2-375</a:t>
              </a:r>
              <a:endParaRPr lang="zh-CN" altLang="en-US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9" name="图片 8" descr="hcs-291-363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732791" y="1906441"/>
            <a:ext cx="2575513" cy="2066400"/>
          </a:xfrm>
          <a:prstGeom prst="rect">
            <a:avLst/>
          </a:prstGeom>
        </p:spPr>
      </p:pic>
      <p:sp>
        <p:nvSpPr>
          <p:cNvPr id="10" name="椭圆 9"/>
          <p:cNvSpPr/>
          <p:nvPr/>
        </p:nvSpPr>
        <p:spPr>
          <a:xfrm rot="3151294" flipV="1">
            <a:off x="5527620" y="2720055"/>
            <a:ext cx="533112" cy="606479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椭圆 10"/>
          <p:cNvSpPr/>
          <p:nvPr/>
        </p:nvSpPr>
        <p:spPr>
          <a:xfrm rot="18967073">
            <a:off x="6165448" y="2638774"/>
            <a:ext cx="564756" cy="558955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94"/>
          <p:cNvSpPr txBox="1"/>
          <p:nvPr/>
        </p:nvSpPr>
        <p:spPr>
          <a:xfrm>
            <a:off x="6156176" y="1947600"/>
            <a:ext cx="1498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mGDIα</a:t>
            </a:r>
            <a:r>
              <a:rPr lang="en-US" altLang="zh-CN" sz="1200" b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2-377</a:t>
            </a:r>
            <a:endParaRPr lang="zh-CN" altLang="en-US" sz="1200" b="1" baseline="30000" dirty="0">
              <a:solidFill>
                <a:prstClr val="black"/>
              </a:solidFill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TextBox 94"/>
          <p:cNvSpPr txBox="1"/>
          <p:nvPr/>
        </p:nvSpPr>
        <p:spPr>
          <a:xfrm>
            <a:off x="4655857" y="1947600"/>
            <a:ext cx="1875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mGDI</a:t>
            </a:r>
            <a:r>
              <a:rPr lang="en-US" altLang="zh-CN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hel</a:t>
            </a:r>
            <a:r>
              <a:rPr lang="en-US" altLang="zh-CN" sz="1200" b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2-363</a:t>
            </a:r>
            <a:endParaRPr lang="zh-CN" altLang="en-US" sz="1200" b="1" baseline="30000" dirty="0">
              <a:solidFill>
                <a:prstClr val="black"/>
              </a:solidFill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25</Words>
  <Application>Microsoft Office PowerPoint</Application>
  <PresentationFormat>On-screen Show (4:3)</PresentationFormat>
  <Paragraphs>20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主题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n, Chuanfu, Nature</cp:lastModifiedBy>
  <cp:revision>22</cp:revision>
  <dcterms:created xsi:type="dcterms:W3CDTF">2018-12-25T14:41:58Z</dcterms:created>
  <dcterms:modified xsi:type="dcterms:W3CDTF">2020-01-02T02:54:43Z</dcterms:modified>
</cp:coreProperties>
</file>